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F067F2-99E5-4AB5-A4E4-DB389658F97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</a:t>
            </a:r>
            <a:r>
              <a:rPr b="0" lang="en-US" sz="1200" spc="-1" strike="noStrike">
                <a:solidFill>
                  <a:srgbClr val="000000"/>
                </a:solidFill>
                <a:latin typeface="ヒラギノ角ゴ Pro W3"/>
              </a:rPr>
              <a:t>_x0010_10: Schematic representation of reconstruction process for iRR1083 for salmonella metabolis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0ACAC-5AE0-4529-9DF8-82259E2B44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FFF365-23DA-4F41-846E-B8DF5DDCE5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7941B-ABA8-41B5-89F3-93B24D3B12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AB6E2-521C-441F-84BA-F73EADAC49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51077-0B17-4EBD-8160-3CE8ADE6FA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C8433-F19D-41E6-867D-F6C3C600D3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9E909-37F7-4918-A9B1-0DBFEBD682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1A854-6C31-41F2-9EE0-06719B0026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8A516-A7ED-4275-8F1F-090D5FF575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F3978-D7C7-4FFB-81D4-5392B9AD82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30F2B-A673-453A-8604-69F3D29A9E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082FB-803E-417E-A75D-B51C27D467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5CECD3-8AFD-4167-AC39-9B9C8D86108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3965400" y="6324480"/>
            <a:ext cx="2362320" cy="45720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755720" y="3903840"/>
            <a:ext cx="762120" cy="1523880"/>
          </a:xfrm>
          <a:custGeom>
            <a:avLst/>
            <a:gdLst>
              <a:gd name="textAreaLeft" fmla="*/ 101880 w 762120"/>
              <a:gd name="textAreaRight" fmla="*/ 660240 w 762120"/>
              <a:gd name="textAreaTop" fmla="*/ 266400 h 1523880"/>
              <a:gd name="textAreaBottom" fmla="*/ 1104840 h 1523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arcTo wR="21600" hR="7560" stAng="-5400000" swAng="-5400000"/>
                <a:lnTo>
                  <a:pt x="0" y="11880"/>
                </a:lnTo>
                <a:arcTo wR="21600" hR="7560" stAng="10800000" swAng="-2682637"/>
                <a:lnTo>
                  <a:pt x="14400" y="21168"/>
                </a:lnTo>
                <a:lnTo>
                  <a:pt x="21600" y="17280"/>
                </a:lnTo>
                <a:lnTo>
                  <a:pt x="14400" y="12528"/>
                </a:lnTo>
                <a:lnTo>
                  <a:pt x="14400" y="14688"/>
                </a:lnTo>
                <a:arcTo wR="21600" hR="7560" stAng="8117363" swAng="2325203"/>
                <a:lnTo>
                  <a:pt x="900" y="9720"/>
                </a:lnTo>
                <a:arcTo wR="21600" hR="7560" stAng="-10442565" swAng="5042565"/>
                <a:close/>
              </a:path>
              <a:path fill="darkenLess" w="21600" h="21600">
                <a:moveTo>
                  <a:pt x="21600" y="0"/>
                </a:moveTo>
                <a:arcTo wR="21600" hR="7560" stAng="-5400000" swAng="-5400000"/>
                <a:lnTo>
                  <a:pt x="0" y="7560"/>
                </a:lnTo>
                <a:arcTo wR="21600" hR="7560" stAng="10800000" swAng="-357435"/>
                <a:lnTo>
                  <a:pt x="900" y="9720"/>
                </a:lnTo>
                <a:arcTo wR="21600" hR="7560" stAng="-10442565" swAng="5042565"/>
                <a:close/>
              </a:path>
            </a:pathLst>
          </a:cu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089840" y="4056120"/>
            <a:ext cx="1143000" cy="1447920"/>
          </a:xfrm>
          <a:custGeom>
            <a:avLst/>
            <a:gdLst>
              <a:gd name="textAreaLeft" fmla="*/ 153000 w 1143000"/>
              <a:gd name="textAreaRight" fmla="*/ 990000 w 1143000"/>
              <a:gd name="textAreaTop" fmla="*/ 253440 h 1447920"/>
              <a:gd name="textAreaBottom" fmla="*/ 1049760 h 1447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arcTo wR="21600" hR="7560" stAng="-5400000" swAng="5400000"/>
                <a:lnTo>
                  <a:pt x="21600" y="11880"/>
                </a:lnTo>
                <a:arcTo wR="21600" hR="7560" stAng="0" swAng="2682637"/>
                <a:lnTo>
                  <a:pt x="7200" y="21168"/>
                </a:lnTo>
                <a:lnTo>
                  <a:pt x="0" y="17280"/>
                </a:lnTo>
                <a:lnTo>
                  <a:pt x="7200" y="12528"/>
                </a:lnTo>
                <a:lnTo>
                  <a:pt x="7200" y="14688"/>
                </a:lnTo>
                <a:arcTo wR="21600" hR="7560" stAng="2682637" swAng="-2325203"/>
                <a:lnTo>
                  <a:pt x="20700" y="9720"/>
                </a:lnTo>
                <a:arcTo wR="21600" hR="7560" stAng="-357435" swAng="-5042565"/>
                <a:close/>
              </a:path>
              <a:path fill="darkenLess" w="21600" h="21600">
                <a:moveTo>
                  <a:pt x="0" y="0"/>
                </a:moveTo>
                <a:arcTo wR="21600" hR="7560" stAng="-5400000" swAng="5400000"/>
                <a:lnTo>
                  <a:pt x="21600" y="11880"/>
                </a:lnTo>
                <a:arcTo wR="21600" hR="7560" stAng="0" swAng="-357435"/>
                <a:lnTo>
                  <a:pt x="20700" y="9720"/>
                </a:lnTo>
                <a:arcTo wR="21600" hR="7560" stAng="-357435" swAng="-5042565"/>
                <a:close/>
              </a:path>
            </a:pathLst>
          </a:cu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365200" y="93600"/>
            <a:ext cx="2286000" cy="76212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41520" y="3751200"/>
            <a:ext cx="2362320" cy="45720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108400" y="3675240"/>
            <a:ext cx="2438640" cy="68580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279600" y="4665600"/>
            <a:ext cx="3429000" cy="114300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279600" y="4894200"/>
            <a:ext cx="342900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Final Salmonella reconstru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R10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365200" y="76320"/>
            <a:ext cx="221004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ome annot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IG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441520" y="3827520"/>
            <a:ext cx="2362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mPheny Auto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413320" y="111240"/>
            <a:ext cx="1676520" cy="76176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413320" y="93600"/>
            <a:ext cx="1600200" cy="78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JR9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184720" y="3675240"/>
            <a:ext cx="2362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E. col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Derived Salmonella 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175440" y="1008000"/>
            <a:ext cx="304560" cy="2438640"/>
          </a:xfrm>
          <a:prstGeom prst="downArrow">
            <a:avLst>
              <a:gd name="adj1" fmla="val 50000"/>
              <a:gd name="adj2" fmla="val 20017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432240" y="1008000"/>
            <a:ext cx="304560" cy="2438640"/>
          </a:xfrm>
          <a:prstGeom prst="downArrow">
            <a:avLst>
              <a:gd name="adj1" fmla="val 50000"/>
              <a:gd name="adj2" fmla="val 20017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632640" y="1066680"/>
            <a:ext cx="2057400" cy="1524240"/>
          </a:xfrm>
          <a:prstGeom prst="foldedCorner">
            <a:avLst>
              <a:gd name="adj" fmla="val 125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298520" y="1236600"/>
            <a:ext cx="1981080" cy="1887480"/>
          </a:xfrm>
          <a:prstGeom prst="foldedCorner">
            <a:avLst>
              <a:gd name="adj" fmla="val 125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118040" y="6338880"/>
            <a:ext cx="220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R1083 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956120" y="5943600"/>
            <a:ext cx="228600" cy="304920"/>
          </a:xfrm>
          <a:prstGeom prst="downArrow">
            <a:avLst>
              <a:gd name="adj1" fmla="val 50000"/>
              <a:gd name="adj2" fmla="val 33346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298520" y="1295280"/>
            <a:ext cx="2057400" cy="181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vidence for ge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tein defini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eaction stoichiomet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mpartmentaliz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etabolite formula and char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632640" y="1066680"/>
            <a:ext cx="2057400" cy="138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omology of STM ge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 factor, primary and secondary metabolite identific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nfirmation of prote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194000" y="1371600"/>
            <a:ext cx="1676520" cy="162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KEG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NIPRO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COCY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TERAT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34360" y="533520"/>
            <a:ext cx="721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1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374840" y="5867280"/>
            <a:ext cx="2209680" cy="762120"/>
          </a:xfrm>
          <a:prstGeom prst="foldedCorner">
            <a:avLst>
              <a:gd name="adj" fmla="val 125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374840" y="5915160"/>
            <a:ext cx="2590560" cy="63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efine system bounda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change (uptake) flux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556320" y="5867280"/>
            <a:ext cx="2209680" cy="762120"/>
          </a:xfrm>
          <a:prstGeom prst="foldedCorner">
            <a:avLst>
              <a:gd name="adj" fmla="val 125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556320" y="5915160"/>
            <a:ext cx="2590920" cy="63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efine genetic constrain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nvironmental perturb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8288280" y="3251160"/>
            <a:ext cx="1807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2400"/>
            </a:b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10T20:10:13Z</dcterms:created>
  <dc:creator>Anu Raghunathan</dc:creator>
  <dc:description/>
  <dc:language>en-US</dc:language>
  <cp:lastModifiedBy>Anu Raghunathan</cp:lastModifiedBy>
  <dcterms:modified xsi:type="dcterms:W3CDTF">2008-10-22T17:20:07Z</dcterms:modified>
  <cp:revision>7</cp:revision>
  <dc:subject/>
  <dc:title>PowerPoint Presentation</dc:title>
</cp:coreProperties>
</file>